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0" d="100"/>
          <a:sy n="80" d="100"/>
        </p:scale>
        <p:origin x="687" y="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3F2C6C6-533D-47AB-9C69-B1D879A41283}"/>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D95B4985-BE54-4A69-BE95-CF518211A96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3353456B-35D3-480D-99D3-D3024997B57D}"/>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30ECBD37-A93F-4BA8-AA7E-7F28B647CAE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433349E-B0CD-423F-908B-1E982D570B74}"/>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36294071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440C806-D6E7-4243-9586-1E219B892A27}"/>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CD91C922-9B5D-419E-9939-4B7936076EF3}"/>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BB22A9D-3DD5-49C4-B934-4F5F2C866425}"/>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704A444B-A92B-470C-B525-2DE6B6F5CCA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AF7B51A-C970-4150-9EFA-70EC6B9C6E28}"/>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9339601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7F4439A1-F57A-4035-B288-5C360524AA32}"/>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77EE7A92-19E0-40CD-86D8-F1D0BE33ACA0}"/>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1081FDD-54EF-422D-BFB8-9F303C1E8748}"/>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B30C0A04-CBB6-4999-9B02-D17B33ACD4F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DCA5F86-5AC2-4B63-B966-AE40605C98CD}"/>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30086911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344316E-2B3F-4CA6-AF97-57547D2FAD5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0B0EC96A-1C90-4A4F-A1C5-6E8145787320}"/>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EB4D219-0718-4B95-80EF-1D477E28166C}"/>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0FECD127-F6A1-420B-9AD1-6148A004C2B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0DB24EE-097F-4AE3-B7A7-6B39CF305288}"/>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18612476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1B51EDC-CFDB-4209-9931-FA404453A64D}"/>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E003053D-1287-4681-BD69-8F428C3718E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EA62A4BC-776D-448D-9A40-13FC58B45DE1}"/>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B7A63E6E-9EB7-4E1E-8C94-83B7E262A75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A8E5DF2-9580-41E2-8096-E94EBDE2F2DB}"/>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2054332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D4DA316-C0D1-4A87-B8DF-E474EB5ACB3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75A8EA0D-6B29-4DC8-857E-4155ED66AE72}"/>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424D8C1F-0651-4ABE-9C38-997AD815E9E0}"/>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49478764-F510-482B-A582-FFD4A6D0CB76}"/>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6" name="页脚占位符 5">
            <a:extLst>
              <a:ext uri="{FF2B5EF4-FFF2-40B4-BE49-F238E27FC236}">
                <a16:creationId xmlns:a16="http://schemas.microsoft.com/office/drawing/2014/main" id="{BFD039C6-2083-4797-93E9-1F045D0026D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FBB6C7D-976F-41C4-9B83-C51A4F9E8E5C}"/>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1209912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F65BCC3-58B6-4F0C-A878-8F138CAC1958}"/>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E586E17-B8CF-4E0D-9715-091327C184F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933CC525-F637-407A-AD46-F8BB3BD6E1C0}"/>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DE4B9B0C-1661-4CD2-B568-C58FB68CBA5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ED5ED665-32EB-4DBB-8A2B-59267426C88E}"/>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4E06A9A4-44DD-4A43-BF2C-EE8FD962AE91}"/>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8" name="页脚占位符 7">
            <a:extLst>
              <a:ext uri="{FF2B5EF4-FFF2-40B4-BE49-F238E27FC236}">
                <a16:creationId xmlns:a16="http://schemas.microsoft.com/office/drawing/2014/main" id="{1B4B407A-7929-47B3-8D14-7157A44DB749}"/>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F2DEF0C7-59D6-4D4A-BB61-F1A06C14C846}"/>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17584916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16F8F5A-3CF3-47E5-8779-421628576F53}"/>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67701615-C663-44EA-9DE5-D1F3BA15B43F}"/>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4" name="页脚占位符 3">
            <a:extLst>
              <a:ext uri="{FF2B5EF4-FFF2-40B4-BE49-F238E27FC236}">
                <a16:creationId xmlns:a16="http://schemas.microsoft.com/office/drawing/2014/main" id="{E5D4AFD1-C5F3-4FD3-BEA8-D6ECB64F15D8}"/>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E50C4F1-E719-4175-9D5D-303D85BCDABE}"/>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33479463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2DEA7A57-4D62-47A8-89FF-461472F6BCE4}"/>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3" name="页脚占位符 2">
            <a:extLst>
              <a:ext uri="{FF2B5EF4-FFF2-40B4-BE49-F238E27FC236}">
                <a16:creationId xmlns:a16="http://schemas.microsoft.com/office/drawing/2014/main" id="{1E1634A9-32BC-4F4C-8C0E-79EDCA0D4EC9}"/>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64501B52-24E2-4875-8C54-D33D2578F17F}"/>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18643466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C1CFC55-4743-4317-B0BF-D98787727836}"/>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6090DBAF-7D7B-42C3-9AAF-31CCFDBA947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447C99E4-DE5B-4188-8B28-0F301A6DAC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C93219F2-ABA6-4319-B7EF-5882C76993BD}"/>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6" name="页脚占位符 5">
            <a:extLst>
              <a:ext uri="{FF2B5EF4-FFF2-40B4-BE49-F238E27FC236}">
                <a16:creationId xmlns:a16="http://schemas.microsoft.com/office/drawing/2014/main" id="{84052FE6-0BF7-4EDF-8D22-3B3454B862E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4AA4AC5-9100-4E34-B1A9-FF1DE515E1FC}"/>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15621037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7F7F348-E733-45E4-9CB1-033E709151F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3F34C995-DFAE-41F8-860C-85437560D6E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514C0FFB-14EC-4C8D-BBB4-E703764A39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1E425A65-774E-4213-A01E-2947C16C001A}"/>
              </a:ext>
            </a:extLst>
          </p:cNvPr>
          <p:cNvSpPr>
            <a:spLocks noGrp="1"/>
          </p:cNvSpPr>
          <p:nvPr>
            <p:ph type="dt" sz="half" idx="10"/>
          </p:nvPr>
        </p:nvSpPr>
        <p:spPr/>
        <p:txBody>
          <a:bodyPr/>
          <a:lstStyle/>
          <a:p>
            <a:fld id="{4F9E42EF-100C-431F-B3D7-551B39BB54F9}" type="datetimeFigureOut">
              <a:rPr lang="zh-CN" altLang="en-US" smtClean="0"/>
              <a:t>2021/4/6</a:t>
            </a:fld>
            <a:endParaRPr lang="zh-CN" altLang="en-US"/>
          </a:p>
        </p:txBody>
      </p:sp>
      <p:sp>
        <p:nvSpPr>
          <p:cNvPr id="6" name="页脚占位符 5">
            <a:extLst>
              <a:ext uri="{FF2B5EF4-FFF2-40B4-BE49-F238E27FC236}">
                <a16:creationId xmlns:a16="http://schemas.microsoft.com/office/drawing/2014/main" id="{9F1A55ED-E895-4565-8962-BA92B43861A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9B32EFE4-A55B-476B-928C-A8B8176D4D70}"/>
              </a:ext>
            </a:extLst>
          </p:cNvPr>
          <p:cNvSpPr>
            <a:spLocks noGrp="1"/>
          </p:cNvSpPr>
          <p:nvPr>
            <p:ph type="sldNum" sz="quarter" idx="12"/>
          </p:nvPr>
        </p:nvSpPr>
        <p:spPr/>
        <p:txBody>
          <a:body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37120272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711C12A5-59A3-4BC1-8E31-BD6C87990D7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327E37D-FD77-4728-B019-FD54FDBE0E0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6DA9276-7545-45C1-940A-F72BF132FB1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F9E42EF-100C-431F-B3D7-551B39BB54F9}" type="datetimeFigureOut">
              <a:rPr lang="zh-CN" altLang="en-US" smtClean="0"/>
              <a:t>2021/4/6</a:t>
            </a:fld>
            <a:endParaRPr lang="zh-CN" altLang="en-US"/>
          </a:p>
        </p:txBody>
      </p:sp>
      <p:sp>
        <p:nvSpPr>
          <p:cNvPr id="5" name="页脚占位符 4">
            <a:extLst>
              <a:ext uri="{FF2B5EF4-FFF2-40B4-BE49-F238E27FC236}">
                <a16:creationId xmlns:a16="http://schemas.microsoft.com/office/drawing/2014/main" id="{65DB051B-4A6A-4706-81EB-D5B38F2197B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9D7240CC-92B6-4F11-AC38-67B8861FA2A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9F890B-F14A-4247-8542-C47677A1140E}" type="slidenum">
              <a:rPr lang="zh-CN" altLang="en-US" smtClean="0"/>
              <a:t>‹#›</a:t>
            </a:fld>
            <a:endParaRPr lang="zh-CN" altLang="en-US"/>
          </a:p>
        </p:txBody>
      </p:sp>
    </p:spTree>
    <p:extLst>
      <p:ext uri="{BB962C8B-B14F-4D97-AF65-F5344CB8AC3E}">
        <p14:creationId xmlns:p14="http://schemas.microsoft.com/office/powerpoint/2010/main" val="34339928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9B2F56D-A9F0-4306-9356-233BBEE9718F}"/>
              </a:ext>
            </a:extLst>
          </p:cNvPr>
          <p:cNvSpPr>
            <a:spLocks noGrp="1"/>
          </p:cNvSpPr>
          <p:nvPr>
            <p:ph type="ctrTitle"/>
          </p:nvPr>
        </p:nvSpPr>
        <p:spPr/>
        <p:txBody>
          <a:bodyPr/>
          <a:lstStyle/>
          <a:p>
            <a:r>
              <a:rPr lang="en-US" altLang="zh-CN" sz="1800" b="1" kern="100" dirty="0">
                <a:effectLst/>
                <a:latin typeface="Times New Roman" panose="02020603050405020304" pitchFamily="18" charset="0"/>
                <a:ea typeface="宋体" panose="02010600030101010101" pitchFamily="2" charset="-122"/>
                <a:cs typeface="Times New Roman" panose="02020603050405020304" pitchFamily="18" charset="0"/>
              </a:rPr>
              <a:t>Supplementary Material </a:t>
            </a:r>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Detailed operation steps and methods of Molecular dynamics simulation</a:t>
            </a:r>
            <a:endParaRPr lang="zh-CN" altLang="en-US" dirty="0"/>
          </a:p>
        </p:txBody>
      </p:sp>
    </p:spTree>
    <p:extLst>
      <p:ext uri="{BB962C8B-B14F-4D97-AF65-F5344CB8AC3E}">
        <p14:creationId xmlns:p14="http://schemas.microsoft.com/office/powerpoint/2010/main" val="39608311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8CFF683-2927-4440-A886-DC3E9B1B3FAB}"/>
              </a:ext>
            </a:extLst>
          </p:cNvPr>
          <p:cNvSpPr>
            <a:spLocks noGrp="1"/>
          </p:cNvSpPr>
          <p:nvPr>
            <p:ph type="title"/>
          </p:nvPr>
        </p:nvSpPr>
        <p:spPr/>
        <p:txBody>
          <a:bodyPr/>
          <a:lstStyle/>
          <a:p>
            <a:r>
              <a:rPr lang="en-US" altLang="zh-CN" sz="1800" b="1" kern="100" dirty="0">
                <a:effectLst/>
                <a:latin typeface="Times New Roman" panose="02020603050405020304" pitchFamily="18" charset="0"/>
                <a:ea typeface="宋体" panose="02010600030101010101" pitchFamily="2" charset="-122"/>
                <a:cs typeface="Times New Roman" panose="02020603050405020304" pitchFamily="18" charset="0"/>
              </a:rPr>
              <a:t>1. Molecular dynamics simulation</a:t>
            </a:r>
            <a:endParaRPr lang="zh-CN" altLang="en-US" dirty="0"/>
          </a:p>
        </p:txBody>
      </p:sp>
      <p:sp>
        <p:nvSpPr>
          <p:cNvPr id="3" name="内容占位符 2">
            <a:extLst>
              <a:ext uri="{FF2B5EF4-FFF2-40B4-BE49-F238E27FC236}">
                <a16:creationId xmlns:a16="http://schemas.microsoft.com/office/drawing/2014/main" id="{6A6D2159-CEFB-4F6E-851D-E1973088D0D9}"/>
              </a:ext>
            </a:extLst>
          </p:cNvPr>
          <p:cNvSpPr>
            <a:spLocks noGrp="1"/>
          </p:cNvSpPr>
          <p:nvPr>
            <p:ph idx="1"/>
          </p:nvPr>
        </p:nvSpPr>
        <p:spPr/>
        <p:txBody>
          <a:bodyPr>
            <a:normAutofit fontScale="92500"/>
          </a:bodyPr>
          <a:lstStyle/>
          <a:p>
            <a:pPr>
              <a:lnSpc>
                <a:spcPct val="150000"/>
              </a:lnSpc>
            </a:pP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The three-dimensional (3D) structure of the EGFR and Dacomitinib complex (PDB ID: 4I24) was downloaded from RCSB database (www.rcsb.org). The Amber 14 </a:t>
            </a:r>
            <a:r>
              <a:rPr lang="en-US" altLang="zh-CN" sz="1800" kern="100" baseline="30000" dirty="0">
                <a:latin typeface="Times New Roman" panose="02020603050405020304" pitchFamily="18" charset="0"/>
                <a:ea typeface="宋体" panose="02010600030101010101" pitchFamily="2" charset="-122"/>
                <a:cs typeface="Times New Roman" panose="02020603050405020304" pitchFamily="18" charset="0"/>
              </a:rPr>
              <a:t>1-3</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and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AmberTools</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15 programs were used for MD simulations of the complex. Dacomitinib was first prepared by ACPYPE </a:t>
            </a:r>
            <a:r>
              <a:rPr lang="en-US" altLang="zh-CN" sz="1800" kern="100" baseline="30000" dirty="0">
                <a:latin typeface="Times New Roman" panose="02020603050405020304" pitchFamily="18" charset="0"/>
                <a:ea typeface="宋体" panose="02010600030101010101" pitchFamily="2" charset="-122"/>
                <a:cs typeface="Times New Roman" panose="02020603050405020304" pitchFamily="18" charset="0"/>
              </a:rPr>
              <a:t>4</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a tool based on ANTECHAMBER </a:t>
            </a:r>
            <a:r>
              <a:rPr lang="en-US" altLang="zh-CN" sz="1800" kern="100" baseline="30000" dirty="0">
                <a:latin typeface="Times New Roman" panose="02020603050405020304" pitchFamily="18" charset="0"/>
                <a:ea typeface="宋体" panose="02010600030101010101" pitchFamily="2" charset="-122"/>
                <a:cs typeface="Times New Roman" panose="02020603050405020304" pitchFamily="18" charset="0"/>
              </a:rPr>
              <a:t>5,6</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for generating automatic topologies and parameters in different formats for different molecular mechanics programs, including calculation of partial charges. Then, the forcefield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leaprc.gaff</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generalized amber forcefield) was used to prepare the ligand, while “leaprc.ff14SB” was used for the receptor. The system was placed in a rectangular box (with a 10.0 Å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boundry</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of TIP3P water using the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SolvateOct</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command with the minimum distance between any solute atoms. Equilibration of the solvated complex was done by carrying out a short minimization (2000 steps of each steepest descent and conjugate gradient method), 1000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ps</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of heating, and 500 </a:t>
            </a:r>
            <a:r>
              <a:rPr lang="en-US" altLang="zh-CN" sz="1800" kern="100" dirty="0" err="1">
                <a:latin typeface="Times New Roman" panose="02020603050405020304" pitchFamily="18" charset="0"/>
                <a:ea typeface="宋体" panose="02010600030101010101" pitchFamily="2" charset="-122"/>
                <a:cs typeface="Times New Roman" panose="02020603050405020304" pitchFamily="18" charset="0"/>
              </a:rPr>
              <a:t>ps</a:t>
            </a:r>
            <a:r>
              <a:rPr lang="en-US" altLang="zh-CN" sz="1800" kern="100" dirty="0">
                <a:latin typeface="Times New Roman" panose="02020603050405020304" pitchFamily="18" charset="0"/>
                <a:ea typeface="宋体" panose="02010600030101010101" pitchFamily="2" charset="-122"/>
                <a:cs typeface="Times New Roman" panose="02020603050405020304" pitchFamily="18" charset="0"/>
              </a:rPr>
              <a:t> of density equilibration with weak restraints using the GPU accelerated PMEMD (Particle Mesh Ewald Molecular Dynamics) module. At last, 40 ns of MD simulations were carried out. All the molecular dynamics were performed on Dell Precision T5500 workstation.</a:t>
            </a:r>
            <a:endParaRPr lang="zh-CN" altLang="en-US" sz="1800" kern="10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4116563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BAA34CC-FEF7-44D2-B019-710DDB0F0D62}"/>
              </a:ext>
            </a:extLst>
          </p:cNvPr>
          <p:cNvSpPr>
            <a:spLocks noGrp="1"/>
          </p:cNvSpPr>
          <p:nvPr>
            <p:ph type="title"/>
          </p:nvPr>
        </p:nvSpPr>
        <p:spPr/>
        <p:txBody>
          <a:bodyPr/>
          <a:lstStyle/>
          <a:p>
            <a:r>
              <a:rPr lang="en-US" altLang="zh-CN" sz="1800" b="1"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2. Binding free energy and energy decomposition per residue calculations</a:t>
            </a:r>
            <a:endParaRPr lang="zh-CN" altLang="en-US" dirty="0"/>
          </a:p>
        </p:txBody>
      </p:sp>
      <p:sp>
        <p:nvSpPr>
          <p:cNvPr id="3" name="内容占位符 2">
            <a:extLst>
              <a:ext uri="{FF2B5EF4-FFF2-40B4-BE49-F238E27FC236}">
                <a16:creationId xmlns:a16="http://schemas.microsoft.com/office/drawing/2014/main" id="{AE404285-CB46-4027-A2F1-5918E1F47C8C}"/>
              </a:ext>
            </a:extLst>
          </p:cNvPr>
          <p:cNvSpPr>
            <a:spLocks noGrp="1"/>
          </p:cNvSpPr>
          <p:nvPr>
            <p:ph idx="1"/>
          </p:nvPr>
        </p:nvSpPr>
        <p:spPr/>
        <p:txBody>
          <a:bodyPr/>
          <a:lstStyle/>
          <a:p>
            <a:pPr indent="127000" algn="just">
              <a:lnSpc>
                <a:spcPct val="150000"/>
              </a:lnSpc>
            </a:pP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The binding free energies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Δ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bind</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in kcal/mol) were calculated using the Molecular Mechanics/Generalized Born Surface Area (MM/GBSA) method,</a:t>
            </a:r>
            <a:r>
              <a:rPr lang="en-US" altLang="zh-CN" sz="1800" kern="0" dirty="0">
                <a:solidFill>
                  <a:srgbClr val="0000FF"/>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implemented in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AmberTools</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15. Moreover, to identify the key protein residues responsible for the ligands binding process, the binding free energy was decomposed on a per-residue basis. For each complex, the binding free energy of MM/GBSA was estimated as follows:</a:t>
            </a:r>
            <a:endParaRPr lang="zh-CN" altLang="zh-CN" sz="1800" kern="100" dirty="0">
              <a:effectLst/>
              <a:latin typeface="Calibri" panose="020F0502020204030204" pitchFamily="34" charset="0"/>
              <a:ea typeface="宋体" panose="02010600030101010101" pitchFamily="2" charset="-122"/>
              <a:cs typeface="Times New Roman" panose="02020603050405020304" pitchFamily="18" charset="0"/>
            </a:endParaRPr>
          </a:p>
          <a:p>
            <a:pPr indent="127000" algn="ctr">
              <a:lnSpc>
                <a:spcPct val="150000"/>
              </a:lnSpc>
            </a:pP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Δ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bind</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omplex</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rotein</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ligand</a:t>
            </a:r>
            <a:endParaRPr lang="zh-CN" altLang="zh-CN" sz="1800" kern="100" dirty="0">
              <a:effectLst/>
              <a:latin typeface="Calibri" panose="020F0502020204030204" pitchFamily="34" charset="0"/>
              <a:ea typeface="宋体" panose="02010600030101010101" pitchFamily="2" charset="-122"/>
              <a:cs typeface="Times New Roman" panose="02020603050405020304" pitchFamily="18" charset="0"/>
            </a:endParaRPr>
          </a:p>
          <a:p>
            <a:pPr indent="127000" algn="just">
              <a:lnSpc>
                <a:spcPct val="150000"/>
              </a:lnSpc>
            </a:pP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where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Δ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bind</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is the binding free energy and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complex</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protein</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nd </a:t>
            </a:r>
            <a:r>
              <a:rPr lang="en-US" altLang="zh-CN" sz="1800" kern="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G</a:t>
            </a:r>
            <a:r>
              <a:rPr lang="en-US" altLang="zh-CN" sz="1800" kern="0" baseline="-25000" dirty="0" err="1">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ligand</a:t>
            </a:r>
            <a:r>
              <a:rPr lang="en-US" altLang="zh-CN" sz="1800" kern="0" dirty="0">
                <a:solidFill>
                  <a:srgbClr val="000000"/>
                </a:solidFill>
                <a:effectLst/>
                <a:latin typeface="Times New Roman" panose="02020603050405020304" pitchFamily="18" charset="0"/>
                <a:ea typeface="宋体" panose="02010600030101010101" pitchFamily="2" charset="-122"/>
                <a:cs typeface="Times New Roman" panose="02020603050405020304" pitchFamily="18" charset="0"/>
              </a:rPr>
              <a:t> are the free energies of complex, protein, and ligand, respectively.</a:t>
            </a:r>
            <a:endParaRPr lang="zh-CN" altLang="zh-CN" sz="1800" kern="100" dirty="0">
              <a:effectLst/>
              <a:latin typeface="Calibri" panose="020F0502020204030204" pitchFamily="34" charset="0"/>
              <a:ea typeface="宋体" panose="02010600030101010101" pitchFamily="2" charset="-122"/>
              <a:cs typeface="Times New Roman" panose="02020603050405020304" pitchFamily="18" charset="0"/>
            </a:endParaRPr>
          </a:p>
          <a:p>
            <a:endParaRPr lang="zh-CN" altLang="en-US" dirty="0"/>
          </a:p>
        </p:txBody>
      </p:sp>
    </p:spTree>
    <p:extLst>
      <p:ext uri="{BB962C8B-B14F-4D97-AF65-F5344CB8AC3E}">
        <p14:creationId xmlns:p14="http://schemas.microsoft.com/office/powerpoint/2010/main" val="14688452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E58217E-634F-44CA-8DE8-8191776EDEC5}"/>
              </a:ext>
            </a:extLst>
          </p:cNvPr>
          <p:cNvSpPr>
            <a:spLocks noGrp="1"/>
          </p:cNvSpPr>
          <p:nvPr>
            <p:ph type="title"/>
          </p:nvPr>
        </p:nvSpPr>
        <p:spPr/>
        <p:txBody>
          <a:bodyPr/>
          <a:lstStyle/>
          <a:p>
            <a:r>
              <a:rPr lang="en-US" altLang="zh-CN" sz="1800" b="1"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References:</a:t>
            </a:r>
            <a:endParaRPr lang="zh-CN" altLang="en-US" sz="1800" b="1"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3" name="内容占位符 2">
            <a:extLst>
              <a:ext uri="{FF2B5EF4-FFF2-40B4-BE49-F238E27FC236}">
                <a16:creationId xmlns:a16="http://schemas.microsoft.com/office/drawing/2014/main" id="{A6EE03F9-369C-4499-8BCB-50D93E2D5067}"/>
              </a:ext>
            </a:extLst>
          </p:cNvPr>
          <p:cNvSpPr>
            <a:spLocks noGrp="1"/>
          </p:cNvSpPr>
          <p:nvPr>
            <p:ph idx="1"/>
          </p:nvPr>
        </p:nvSpPr>
        <p:spPr/>
        <p:txBody>
          <a:bodyPr>
            <a:normAutofit lnSpcReduction="10000"/>
          </a:bodyPr>
          <a:lstStyle/>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1.     Pierce LC, Salomon-Ferrer R, Augusto F. de Oliveira C, McCammon JA, Walker RC. Routine access to millisecond time scale events with accelerated molecular dynamics. J Chem Theory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Comput</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2012;8(9):2997-3002.</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2.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Götz</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W, Williamson MJ, Xu D, Poole D, Le Grand S, Walker RC. Routine microsecond molecular dynamics simulations with AMBER on GPUs. 1. Generalized Born. Journal of chemical theory and computation. 2012;8(5):1542-1555.</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3.	Salomon-Ferrer R,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Götz</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W, Poole D, Le Grand S, Walker RC. Routine microsecond molecular dynamics simulations with Amber on GPUs. 2. Explicit solvent particle mesh Ewald. Journal of Chemical Theory and Computation. 2013;9(9):3878-3888.</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4.	da Silva AWS,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Vranken</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WF. ACPYPE-Antechamber python parser interface. BMC Res Notes. 2012;5(1):367.</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5.	Wang J, Wolf RM, Caldwell JW,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Kollman</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PA, Case DA. Development and testing of a general amber force field. J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Comput</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Chem. 2004;25(9):1157-1174.</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pPr marL="457200" indent="0">
              <a:buNone/>
            </a:pP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6.	Wang J, Wang W, </a:t>
            </a:r>
            <a:r>
              <a:rPr lang="en-US" altLang="zh-CN" sz="1800" kern="0" dirty="0" err="1">
                <a:solidFill>
                  <a:srgbClr val="000000"/>
                </a:solidFill>
                <a:latin typeface="Times New Roman" panose="02020603050405020304" pitchFamily="18" charset="0"/>
                <a:ea typeface="宋体" panose="02010600030101010101" pitchFamily="2" charset="-122"/>
                <a:cs typeface="Times New Roman" panose="02020603050405020304" pitchFamily="18" charset="0"/>
              </a:rPr>
              <a:t>Kollman</a:t>
            </a:r>
            <a:r>
              <a:rPr lang="en-US"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PA, Case DA. Automatic atom type and bond type perception in molecular mechanical calculations. J Mol Graph Model. 2006;25(2):247-260.</a:t>
            </a:r>
            <a:endParaRPr lang="zh-CN" altLang="zh-CN" sz="1800" kern="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endParaRPr>
          </a:p>
          <a:p>
            <a:endParaRPr lang="zh-CN" altLang="en-US" dirty="0"/>
          </a:p>
        </p:txBody>
      </p:sp>
    </p:spTree>
    <p:extLst>
      <p:ext uri="{BB962C8B-B14F-4D97-AF65-F5344CB8AC3E}">
        <p14:creationId xmlns:p14="http://schemas.microsoft.com/office/powerpoint/2010/main" val="43436909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602</Words>
  <Application>Microsoft Office PowerPoint</Application>
  <PresentationFormat>宽屏</PresentationFormat>
  <Paragraphs>14</Paragraphs>
  <Slides>4</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4</vt:i4>
      </vt:variant>
    </vt:vector>
  </HeadingPairs>
  <TitlesOfParts>
    <vt:vector size="10" baseType="lpstr">
      <vt:lpstr>等线</vt:lpstr>
      <vt:lpstr>等线 Light</vt:lpstr>
      <vt:lpstr>Arial</vt:lpstr>
      <vt:lpstr>Calibri</vt:lpstr>
      <vt:lpstr>Times New Roman</vt:lpstr>
      <vt:lpstr>Office 主题​​</vt:lpstr>
      <vt:lpstr>Supplementary Material Detailed operation steps and methods of Molecular dynamics simulation</vt:lpstr>
      <vt:lpstr>1. Molecular dynamics simulation</vt:lpstr>
      <vt:lpstr>2. Binding free energy and energy decomposition per residue calcula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 Detailed operation steps and methods of Molecular dynamics simulation</dc:title>
  <dc:creator>李鸿帅</dc:creator>
  <cp:lastModifiedBy>李鸿帅</cp:lastModifiedBy>
  <cp:revision>1</cp:revision>
  <dcterms:created xsi:type="dcterms:W3CDTF">2021-04-06T12:41:57Z</dcterms:created>
  <dcterms:modified xsi:type="dcterms:W3CDTF">2021-04-06T12:46:54Z</dcterms:modified>
</cp:coreProperties>
</file>